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ne B. Curtis" initials="ABC" lastIdx="1" clrIdx="0">
    <p:extLst>
      <p:ext uri="{19B8F6BF-5375-455C-9EA6-DF929625EA0E}">
        <p15:presenceInfo xmlns:p15="http://schemas.microsoft.com/office/powerpoint/2012/main" userId="Anne B. Curtis" providerId="None"/>
      </p:ext>
    </p:extLst>
  </p:cmAuthor>
  <p:cmAuthor id="2" name="Jacobsen, Luke" initials="JL" lastIdx="1" clrIdx="1">
    <p:extLst>
      <p:ext uri="{19B8F6BF-5375-455C-9EA6-DF929625EA0E}">
        <p15:presenceInfo xmlns:p15="http://schemas.microsoft.com/office/powerpoint/2012/main" userId="S::jacobl15@medtronic.com::371e7fa7-6711-4314-9318-686e4668d8b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200" d="100"/>
          <a:sy n="200" d="100"/>
        </p:scale>
        <p:origin x="-312" y="-9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200" d="100"/>
          <a:sy n="200" d="100"/>
        </p:scale>
        <p:origin x="588" y="-177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89D85D-51A5-47DD-9450-082AC00BA30C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77CCA0-DA12-459C-981D-90AAB18642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48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Flow diagram showing the hierarchy as to how patients were assigned to different indications for guideline-directed device therapy. </a:t>
            </a:r>
            <a:r>
              <a:rPr lang="en-US" sz="18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V=atrioventricular; CRT-D=cardiac resynchronization therapy-defibrillator; ICD=implantable cardioverter defibrillator; LBBB=left bundle branch block; ; LVEF=left ventricular ejection fraction; NYHA=New York Heart Association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77CCA0-DA12-459C-981D-90AAB186428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67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299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42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021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999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978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20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282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496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178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026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909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CFAFF-F4A2-4141-A914-BE03254F5EE5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4718B-4934-4279-B3C1-9C9C20D5E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420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85A76F59-CDE6-4D86-A62A-B7596FD8CB8F}"/>
              </a:ext>
            </a:extLst>
          </p:cNvPr>
          <p:cNvSpPr/>
          <p:nvPr/>
        </p:nvSpPr>
        <p:spPr>
          <a:xfrm>
            <a:off x="2883176" y="102335"/>
            <a:ext cx="1091646" cy="33020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in Optum database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73A30475-D84B-4627-82B1-E242CD5A83D5}"/>
              </a:ext>
            </a:extLst>
          </p:cNvPr>
          <p:cNvCxnSpPr>
            <a:cxnSpLocks/>
            <a:stCxn id="4" idx="2"/>
            <a:endCxn id="8" idx="0"/>
          </p:cNvCxnSpPr>
          <p:nvPr/>
        </p:nvCxnSpPr>
        <p:spPr>
          <a:xfrm>
            <a:off x="3428999" y="432535"/>
            <a:ext cx="0" cy="21019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D7FC6597-C6FE-4637-AC1C-F4370DB24DAF}"/>
              </a:ext>
            </a:extLst>
          </p:cNvPr>
          <p:cNvSpPr/>
          <p:nvPr/>
        </p:nvSpPr>
        <p:spPr>
          <a:xfrm>
            <a:off x="2883176" y="642730"/>
            <a:ext cx="1091646" cy="35670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screening diagnosis and LVEF ≤ 35% 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1BF4A732-3E1D-49D4-8786-2A51A3B3EF96}"/>
              </a:ext>
            </a:extLst>
          </p:cNvPr>
          <p:cNvCxnSpPr>
            <a:cxnSpLocks/>
          </p:cNvCxnSpPr>
          <p:nvPr/>
        </p:nvCxnSpPr>
        <p:spPr>
          <a:xfrm>
            <a:off x="3428999" y="999435"/>
            <a:ext cx="0" cy="23670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FCF48B7F-39DD-4A03-BB2F-18D886DBE20E}"/>
              </a:ext>
            </a:extLst>
          </p:cNvPr>
          <p:cNvSpPr/>
          <p:nvPr/>
        </p:nvSpPr>
        <p:spPr>
          <a:xfrm>
            <a:off x="2883176" y="1236134"/>
            <a:ext cx="1091646" cy="35670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that do not meet exclusion criteria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2F15313A-7B3F-437D-9C1E-79FACF093911}"/>
              </a:ext>
            </a:extLst>
          </p:cNvPr>
          <p:cNvCxnSpPr>
            <a:cxnSpLocks/>
          </p:cNvCxnSpPr>
          <p:nvPr/>
        </p:nvCxnSpPr>
        <p:spPr>
          <a:xfrm>
            <a:off x="3428999" y="1592839"/>
            <a:ext cx="0" cy="23670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4AF20B3E-60E1-4CE6-BA88-81CDF6F9A68C}"/>
              </a:ext>
            </a:extLst>
          </p:cNvPr>
          <p:cNvSpPr/>
          <p:nvPr/>
        </p:nvSpPr>
        <p:spPr>
          <a:xfrm>
            <a:off x="2420591" y="1829538"/>
            <a:ext cx="2016815" cy="120594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-D Class I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atient has evidence of all of the following: 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BB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RS &gt; 150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ther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ii:</a:t>
            </a:r>
          </a:p>
          <a:p>
            <a:pPr marL="685800" lvl="1" indent="-228600">
              <a:buFont typeface="+mj-lt"/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YHA 2 or 3</a:t>
            </a:r>
          </a:p>
          <a:p>
            <a:pPr marL="685800" lvl="1" indent="-228600">
              <a:buFont typeface="+mj-lt"/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EF ≤ 30% with ischemic heart disease </a:t>
            </a:r>
          </a:p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7" name="Rectangle: Rounded Corners 16">
            <a:extLst>
              <a:ext uri="{FF2B5EF4-FFF2-40B4-BE49-F238E27FC236}">
                <a16:creationId xmlns:a16="http://schemas.microsoft.com/office/drawing/2014/main" id="{CFF28A0F-6C44-4DB1-82F2-85180B237661}"/>
              </a:ext>
            </a:extLst>
          </p:cNvPr>
          <p:cNvSpPr/>
          <p:nvPr/>
        </p:nvSpPr>
        <p:spPr>
          <a:xfrm>
            <a:off x="3646417" y="3371579"/>
            <a:ext cx="2016815" cy="120594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-D Class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Ia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 LBBB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atient has evidence of all of the following: 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RS &gt; 150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ther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:</a:t>
            </a:r>
          </a:p>
          <a:p>
            <a:pPr marL="685800" lvl="1" indent="-228600">
              <a:buFont typeface="+mj-lt"/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YHA 2 or 3</a:t>
            </a:r>
          </a:p>
          <a:p>
            <a:pPr marL="685800" lvl="1" indent="-228600">
              <a:buFont typeface="+mj-lt"/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EF ≤ 30% with ischemic heart disease </a:t>
            </a:r>
          </a:p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D6BB8DBF-0783-42B9-974D-D56AEAD8FAF4}"/>
              </a:ext>
            </a:extLst>
          </p:cNvPr>
          <p:cNvCxnSpPr>
            <a:cxnSpLocks/>
            <a:stCxn id="15" idx="2"/>
            <a:endCxn id="17" idx="0"/>
          </p:cNvCxnSpPr>
          <p:nvPr/>
        </p:nvCxnSpPr>
        <p:spPr>
          <a:xfrm>
            <a:off x="3428999" y="3035483"/>
            <a:ext cx="1225826" cy="33609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AA33EFF6-E357-484B-AF57-A7214C89AAF6}"/>
              </a:ext>
            </a:extLst>
          </p:cNvPr>
          <p:cNvCxnSpPr>
            <a:cxnSpLocks/>
            <a:stCxn id="15" idx="2"/>
          </p:cNvCxnSpPr>
          <p:nvPr/>
        </p:nvCxnSpPr>
        <p:spPr>
          <a:xfrm flipH="1">
            <a:off x="2355574" y="3035483"/>
            <a:ext cx="1073425" cy="33609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Rectangle: Rounded Corners 23">
            <a:extLst>
              <a:ext uri="{FF2B5EF4-FFF2-40B4-BE49-F238E27FC236}">
                <a16:creationId xmlns:a16="http://schemas.microsoft.com/office/drawing/2014/main" id="{98695DFF-1B3A-4904-985B-2C76D22CAD1B}"/>
              </a:ext>
            </a:extLst>
          </p:cNvPr>
          <p:cNvSpPr/>
          <p:nvPr/>
        </p:nvSpPr>
        <p:spPr>
          <a:xfrm>
            <a:off x="1303473" y="3371579"/>
            <a:ext cx="2016815" cy="120594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-D Class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Ia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BBB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atient has evidence of all of the following: 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BB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RS 120-149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ther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ii:</a:t>
            </a:r>
          </a:p>
          <a:p>
            <a:pPr marL="685800" lvl="1" indent="-228600">
              <a:buFont typeface="+mj-lt"/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YHA 2 or 3</a:t>
            </a:r>
          </a:p>
          <a:p>
            <a:pPr marL="685800" lvl="1" indent="-228600">
              <a:buFont typeface="+mj-lt"/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EF ≤ 30% with ischemic heart disease </a:t>
            </a:r>
          </a:p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7" name="Rectangle: Rounded Corners 26">
            <a:extLst>
              <a:ext uri="{FF2B5EF4-FFF2-40B4-BE49-F238E27FC236}">
                <a16:creationId xmlns:a16="http://schemas.microsoft.com/office/drawing/2014/main" id="{11EDD74F-99A2-4B3E-AC95-568BBD5D9282}"/>
              </a:ext>
            </a:extLst>
          </p:cNvPr>
          <p:cNvSpPr/>
          <p:nvPr/>
        </p:nvSpPr>
        <p:spPr>
          <a:xfrm>
            <a:off x="2420590" y="4837523"/>
            <a:ext cx="2016815" cy="1700438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-D Other Class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Ia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atient has evidence of 1 or 2: 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th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i:</a:t>
            </a:r>
          </a:p>
          <a:p>
            <a:pPr marL="742950" lvl="1" indent="-285750"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YHA 2 or 3 with ischemic heart disease</a:t>
            </a:r>
          </a:p>
          <a:p>
            <a:pPr marL="742950" lvl="1" indent="-285750"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idence of high degree AV block 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th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i:</a:t>
            </a:r>
          </a:p>
          <a:p>
            <a:pPr marL="685800" lvl="1" indent="-228600">
              <a:buFont typeface="+mj-lt"/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idence of life threatening arrhythmia</a:t>
            </a:r>
          </a:p>
          <a:p>
            <a:pPr marL="685800" lvl="1" indent="-228600">
              <a:buFont typeface="+mj-lt"/>
              <a:buAutoNum type="romanL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RS &gt; 150 or LBBB</a:t>
            </a:r>
          </a:p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7C6F3951-F17D-41A0-A75F-3CAC92AC5CC9}"/>
              </a:ext>
            </a:extLst>
          </p:cNvPr>
          <p:cNvCxnSpPr>
            <a:cxnSpLocks/>
            <a:stCxn id="17" idx="2"/>
            <a:endCxn id="27" idx="0"/>
          </p:cNvCxnSpPr>
          <p:nvPr/>
        </p:nvCxnSpPr>
        <p:spPr>
          <a:xfrm flipH="1">
            <a:off x="3428998" y="4577524"/>
            <a:ext cx="1225827" cy="25999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D1C78379-F889-48C5-88A7-0A654ECA8FD9}"/>
              </a:ext>
            </a:extLst>
          </p:cNvPr>
          <p:cNvCxnSpPr>
            <a:cxnSpLocks/>
            <a:stCxn id="24" idx="2"/>
            <a:endCxn id="27" idx="0"/>
          </p:cNvCxnSpPr>
          <p:nvPr/>
        </p:nvCxnSpPr>
        <p:spPr>
          <a:xfrm>
            <a:off x="2311881" y="4577524"/>
            <a:ext cx="1117117" cy="25999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Rectangle: Rounded Corners 38">
            <a:extLst>
              <a:ext uri="{FF2B5EF4-FFF2-40B4-BE49-F238E27FC236}">
                <a16:creationId xmlns:a16="http://schemas.microsoft.com/office/drawing/2014/main" id="{295F2841-E352-4858-B2BC-E2E935D50370}"/>
              </a:ext>
            </a:extLst>
          </p:cNvPr>
          <p:cNvSpPr/>
          <p:nvPr/>
        </p:nvSpPr>
        <p:spPr>
          <a:xfrm>
            <a:off x="2420589" y="6751505"/>
            <a:ext cx="2016815" cy="47606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D Secondary Prevention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atient has evidence of life threatening arrhythmia.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72B439BD-6AF3-48AF-88C3-A14A0331DB25}"/>
              </a:ext>
            </a:extLst>
          </p:cNvPr>
          <p:cNvCxnSpPr>
            <a:cxnSpLocks/>
            <a:stCxn id="27" idx="2"/>
            <a:endCxn id="39" idx="0"/>
          </p:cNvCxnSpPr>
          <p:nvPr/>
        </p:nvCxnSpPr>
        <p:spPr>
          <a:xfrm flipH="1">
            <a:off x="3428997" y="6537961"/>
            <a:ext cx="1" cy="21354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4" name="Rectangle: Rounded Corners 43">
            <a:extLst>
              <a:ext uri="{FF2B5EF4-FFF2-40B4-BE49-F238E27FC236}">
                <a16:creationId xmlns:a16="http://schemas.microsoft.com/office/drawing/2014/main" id="{4C7D2A8E-5FC9-4EFE-B5F7-72655732C439}"/>
              </a:ext>
            </a:extLst>
          </p:cNvPr>
          <p:cNvSpPr/>
          <p:nvPr/>
        </p:nvSpPr>
        <p:spPr>
          <a:xfrm>
            <a:off x="2420585" y="7453733"/>
            <a:ext cx="2016815" cy="81615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D Primary Prevention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atient has evidence of 1 or 2:</a:t>
            </a:r>
          </a:p>
          <a:p>
            <a:pPr marL="228600" indent="-228600"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YHA 2 or 3</a:t>
            </a:r>
          </a:p>
          <a:p>
            <a:pPr marL="228600" indent="-228600"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EF ≤ 30% with ischemic heart disease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F18B155-2440-4E64-9666-204AA2CF3E7C}"/>
              </a:ext>
            </a:extLst>
          </p:cNvPr>
          <p:cNvCxnSpPr>
            <a:cxnSpLocks/>
          </p:cNvCxnSpPr>
          <p:nvPr/>
        </p:nvCxnSpPr>
        <p:spPr>
          <a:xfrm flipH="1">
            <a:off x="3428992" y="7238256"/>
            <a:ext cx="1" cy="21354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6" name="Rectangle: Rounded Corners 45">
            <a:extLst>
              <a:ext uri="{FF2B5EF4-FFF2-40B4-BE49-F238E27FC236}">
                <a16:creationId xmlns:a16="http://schemas.microsoft.com/office/drawing/2014/main" id="{0D2FD52B-D318-4A17-96C1-C89DD00EBB4E}"/>
              </a:ext>
            </a:extLst>
          </p:cNvPr>
          <p:cNvSpPr/>
          <p:nvPr/>
        </p:nvSpPr>
        <p:spPr>
          <a:xfrm>
            <a:off x="2420585" y="8496045"/>
            <a:ext cx="2016815" cy="871669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D Arrhythmic Cardiomyopathy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atient has evidence of all of the following:</a:t>
            </a:r>
          </a:p>
          <a:p>
            <a:pPr marL="228600" indent="-228600"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diomyopathy</a:t>
            </a:r>
          </a:p>
          <a:p>
            <a:pPr marL="228600" indent="-228600">
              <a:buAutoNum type="arabicPeriod"/>
            </a:pP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cope or ventricular tachycardia not clearly classified as life threatening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B008B03A-3269-4434-A1CC-310EA43D9500}"/>
              </a:ext>
            </a:extLst>
          </p:cNvPr>
          <p:cNvCxnSpPr>
            <a:cxnSpLocks/>
            <a:endCxn id="46" idx="0"/>
          </p:cNvCxnSpPr>
          <p:nvPr/>
        </p:nvCxnSpPr>
        <p:spPr>
          <a:xfrm>
            <a:off x="3428993" y="8269883"/>
            <a:ext cx="0" cy="22616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351634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295</Words>
  <Application>Microsoft Office PowerPoint</Application>
  <PresentationFormat>Widescreen</PresentationFormat>
  <Paragraphs>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cobsen, Luke</dc:creator>
  <cp:lastModifiedBy>Anne B. Curtis</cp:lastModifiedBy>
  <cp:revision>12</cp:revision>
  <cp:lastPrinted>2021-09-22T10:39:07Z</cp:lastPrinted>
  <dcterms:created xsi:type="dcterms:W3CDTF">2021-08-25T16:36:25Z</dcterms:created>
  <dcterms:modified xsi:type="dcterms:W3CDTF">2021-10-06T18:15:53Z</dcterms:modified>
</cp:coreProperties>
</file>